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1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840">
          <p15:clr>
            <a:srgbClr val="A4A3A4"/>
          </p15:clr>
        </p15:guide>
        <p15:guide id="2" pos="1936">
          <p15:clr>
            <a:srgbClr val="A4A3A4"/>
          </p15:clr>
        </p15:guide>
        <p15:guide id="3" pos="344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ortier, Stephanie" initials="FS" lastIdx="4" clrIdx="0">
    <p:extLst/>
  </p:cmAuthor>
  <p:cmAuthor id="2" name="Andrew Stiff" initials="" lastIdx="0" clrIdx="1"/>
  <p:cmAuthor id="3" name="Sobrina Wesolowski" initials="SW" lastIdx="1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FF00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803" autoAdjust="0"/>
    <p:restoredTop sz="93918" autoAdjust="0"/>
  </p:normalViewPr>
  <p:slideViewPr>
    <p:cSldViewPr snapToGrid="0">
      <p:cViewPr varScale="1">
        <p:scale>
          <a:sx n="48" d="100"/>
          <a:sy n="48" d="100"/>
        </p:scale>
        <p:origin x="-3108" y="-120"/>
      </p:cViewPr>
      <p:guideLst>
        <p:guide orient="horz" pos="3840"/>
        <p:guide pos="1936"/>
        <p:guide pos="34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BB1863-6C78-4199-A00B-2F07DD958D56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426DA3-EA64-413C-AC60-7E90D2A034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8213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207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550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053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273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722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786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509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666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45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74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645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443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53692" y="393696"/>
            <a:ext cx="58582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2. Surgical management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90869806"/>
              </p:ext>
            </p:extLst>
          </p:nvPr>
        </p:nvGraphicFramePr>
        <p:xfrm>
          <a:off x="453693" y="672427"/>
          <a:ext cx="6139612" cy="46816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571253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68359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 sz="14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All</a:t>
                      </a:r>
                      <a:r>
                        <a:rPr lang="en-US" sz="1400" b="1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Patients</a:t>
                      </a:r>
                      <a:endParaRPr lang="en-US" sz="1400" b="1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b="1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2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Ipsilateral lumpectomy with sentinel</a:t>
                      </a:r>
                      <a:r>
                        <a:rPr lang="en-US" sz="1400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lymph node biopsy</a:t>
                      </a:r>
                      <a:endParaRPr lang="en-US" sz="14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Ipsilateral total mastectomy with axillary lymph node dissec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Ipsilateral total mastectomy with axillary lymph node dissection and contralateral prophylactic total mastectomy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Ipsilateral lumpectomy with axillary lymph node dissec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Ipsilateral total mastectomy with sentinel lymph node biops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Ipsilateral</a:t>
                      </a:r>
                      <a:r>
                        <a:rPr lang="en-US" sz="1400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partial mastectomy with sentinel lymph node biopsy</a:t>
                      </a:r>
                      <a:endParaRPr lang="en-US" sz="14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385544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Ipsilateral partial mastectomy with axillary lymph node dissec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568426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0" u="none" strike="noStrike" kern="1200" baseline="0" dirty="0">
                          <a:solidFill>
                            <a:schemeClr val="tx1"/>
                          </a:solidFill>
                          <a:latin typeface="Arial"/>
                          <a:ea typeface="+mn-ea"/>
                          <a:cs typeface="Arial"/>
                        </a:rPr>
                        <a:t>Ipsilateral total mastectomy with sentinel lymph node biopsy and contralateral prophylactic total mastectom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4285166771"/>
                  </a:ext>
                </a:extLst>
              </a:tr>
              <a:tr h="61361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Ipsilateral</a:t>
                      </a:r>
                      <a:r>
                        <a:rPr lang="en-US" sz="1400" baseline="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 total mastectomy alone; had axillary lymph node dissection with prior ipsilateral lumpectomy</a:t>
                      </a:r>
                      <a:endParaRPr lang="en-US" sz="1400" dirty="0">
                        <a:solidFill>
                          <a:schemeClr val="tx1"/>
                        </a:solidFill>
                        <a:latin typeface="Arial"/>
                        <a:cs typeface="Arial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400" dirty="0">
                          <a:solidFill>
                            <a:schemeClr val="tx1"/>
                          </a:solidFill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1902961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518846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928</TotalTime>
  <Words>105</Words>
  <Application>Microsoft Office PowerPoint</Application>
  <PresentationFormat>Custom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Ohio State University Wexner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iff, Andrew</dc:creator>
  <cp:lastModifiedBy>MPABLEO</cp:lastModifiedBy>
  <cp:revision>188</cp:revision>
  <dcterms:created xsi:type="dcterms:W3CDTF">2018-09-28T15:43:32Z</dcterms:created>
  <dcterms:modified xsi:type="dcterms:W3CDTF">2020-05-13T11:09:20Z</dcterms:modified>
</cp:coreProperties>
</file>